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9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216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2" d="100"/>
          <a:sy n="82" d="100"/>
        </p:scale>
        <p:origin x="1182" y="9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18DAAA-4309-4B5E-ACD7-AED8D6E0CB90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83CBBA-35D2-4D97-97E2-D7B083AB20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797997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529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5366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3764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2208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8139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512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792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3013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5166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1309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5682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9777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AE43CD75-F22B-4E09-B880-D5BF81CBDF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9891758"/>
              </p:ext>
            </p:extLst>
          </p:nvPr>
        </p:nvGraphicFramePr>
        <p:xfrm>
          <a:off x="297316" y="981075"/>
          <a:ext cx="6080254" cy="650983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24840">
                  <a:extLst>
                    <a:ext uri="{9D8B030D-6E8A-4147-A177-3AD203B41FA5}">
                      <a16:colId xmlns:a16="http://schemas.microsoft.com/office/drawing/2014/main" val="3855201218"/>
                    </a:ext>
                  </a:extLst>
                </a:gridCol>
                <a:gridCol w="1306694">
                  <a:extLst>
                    <a:ext uri="{9D8B030D-6E8A-4147-A177-3AD203B41FA5}">
                      <a16:colId xmlns:a16="http://schemas.microsoft.com/office/drawing/2014/main" val="4103073829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793153337"/>
                    </a:ext>
                  </a:extLst>
                </a:gridCol>
                <a:gridCol w="429690">
                  <a:extLst>
                    <a:ext uri="{9D8B030D-6E8A-4147-A177-3AD203B41FA5}">
                      <a16:colId xmlns:a16="http://schemas.microsoft.com/office/drawing/2014/main" val="1249880799"/>
                    </a:ext>
                  </a:extLst>
                </a:gridCol>
                <a:gridCol w="429690">
                  <a:extLst>
                    <a:ext uri="{9D8B030D-6E8A-4147-A177-3AD203B41FA5}">
                      <a16:colId xmlns:a16="http://schemas.microsoft.com/office/drawing/2014/main" val="2168521386"/>
                    </a:ext>
                  </a:extLst>
                </a:gridCol>
                <a:gridCol w="429690">
                  <a:extLst>
                    <a:ext uri="{9D8B030D-6E8A-4147-A177-3AD203B41FA5}">
                      <a16:colId xmlns:a16="http://schemas.microsoft.com/office/drawing/2014/main" val="98794060"/>
                    </a:ext>
                  </a:extLst>
                </a:gridCol>
                <a:gridCol w="429690">
                  <a:extLst>
                    <a:ext uri="{9D8B030D-6E8A-4147-A177-3AD203B41FA5}">
                      <a16:colId xmlns:a16="http://schemas.microsoft.com/office/drawing/2014/main" val="2770798733"/>
                    </a:ext>
                  </a:extLst>
                </a:gridCol>
                <a:gridCol w="429690">
                  <a:extLst>
                    <a:ext uri="{9D8B030D-6E8A-4147-A177-3AD203B41FA5}">
                      <a16:colId xmlns:a16="http://schemas.microsoft.com/office/drawing/2014/main" val="2573856767"/>
                    </a:ext>
                  </a:extLst>
                </a:gridCol>
                <a:gridCol w="429690">
                  <a:extLst>
                    <a:ext uri="{9D8B030D-6E8A-4147-A177-3AD203B41FA5}">
                      <a16:colId xmlns:a16="http://schemas.microsoft.com/office/drawing/2014/main" val="3932897478"/>
                    </a:ext>
                  </a:extLst>
                </a:gridCol>
                <a:gridCol w="429690">
                  <a:extLst>
                    <a:ext uri="{9D8B030D-6E8A-4147-A177-3AD203B41FA5}">
                      <a16:colId xmlns:a16="http://schemas.microsoft.com/office/drawing/2014/main" val="2049313260"/>
                    </a:ext>
                  </a:extLst>
                </a:gridCol>
                <a:gridCol w="429690">
                  <a:extLst>
                    <a:ext uri="{9D8B030D-6E8A-4147-A177-3AD203B41FA5}">
                      <a16:colId xmlns:a16="http://schemas.microsoft.com/office/drawing/2014/main" val="1527821221"/>
                    </a:ext>
                  </a:extLst>
                </a:gridCol>
              </a:tblGrid>
              <a:tr h="1181100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</a:rPr>
                        <a:t> </a:t>
                      </a:r>
                      <a:endParaRPr lang="de-DE" sz="90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</a:rPr>
                        <a:t> </a:t>
                      </a:r>
                      <a:endParaRPr lang="de-DE" sz="90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u="none" strike="noStrike" dirty="0">
                          <a:effectLst/>
                        </a:rPr>
                        <a:t> </a:t>
                      </a:r>
                      <a:endParaRPr lang="de-DE" sz="90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dirty="0"/>
                        <a:t>Stress </a:t>
                      </a:r>
                      <a:r>
                        <a:rPr lang="de-DE" sz="900" dirty="0" err="1"/>
                        <a:t>caused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by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unsecurity</a:t>
                      </a:r>
                      <a:endParaRPr lang="de-DE" sz="900" dirty="0"/>
                    </a:p>
                  </a:txBody>
                  <a:tcPr marL="6161" marR="6161" marT="6161" marB="0" vert="vert27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dirty="0"/>
                        <a:t>Stress caused by being overwhelmed</a:t>
                      </a:r>
                    </a:p>
                  </a:txBody>
                  <a:tcPr marL="6161" marR="6161" marT="6161" marB="0" vert="vert27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dirty="0"/>
                        <a:t>Stress </a:t>
                      </a:r>
                      <a:r>
                        <a:rPr lang="de-DE" sz="900" dirty="0" err="1"/>
                        <a:t>caused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by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loss</a:t>
                      </a:r>
                      <a:endParaRPr lang="de-DE" sz="900" dirty="0"/>
                    </a:p>
                  </a:txBody>
                  <a:tcPr marL="6161" marR="6161" marT="6161" marB="0" vert="vert27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dirty="0"/>
                        <a:t>Stress </a:t>
                      </a:r>
                      <a:r>
                        <a:rPr lang="de-DE" sz="900" dirty="0" err="1"/>
                        <a:t>symptoms</a:t>
                      </a:r>
                      <a:endParaRPr lang="de-DE" sz="900" dirty="0"/>
                    </a:p>
                  </a:txBody>
                  <a:tcPr marL="6161" marR="6161" marT="6161" marB="0" vert="vert27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dirty="0"/>
                        <a:t>Positive </a:t>
                      </a:r>
                      <a:r>
                        <a:rPr lang="de-DE" sz="900" dirty="0" err="1"/>
                        <a:t>coping</a:t>
                      </a:r>
                      <a:endParaRPr lang="de-DE" sz="900" dirty="0"/>
                    </a:p>
                  </a:txBody>
                  <a:tcPr marL="6161" marR="6161" marT="6161" marB="0" vert="vert27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dirty="0" err="1"/>
                        <a:t>Active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ping</a:t>
                      </a:r>
                      <a:endParaRPr lang="de-DE" sz="900" dirty="0"/>
                    </a:p>
                  </a:txBody>
                  <a:tcPr marL="6161" marR="6161" marT="6161" marB="0" vert="vert27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dirty="0"/>
                        <a:t>Coping </a:t>
                      </a:r>
                      <a:r>
                        <a:rPr lang="de-DE" sz="900" dirty="0" err="1"/>
                        <a:t>by</a:t>
                      </a:r>
                      <a:r>
                        <a:rPr lang="de-DE" sz="900" dirty="0"/>
                        <a:t> support</a:t>
                      </a:r>
                    </a:p>
                  </a:txBody>
                  <a:tcPr marL="6161" marR="6161" marT="6161" marB="0" vert="vert27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dirty="0"/>
                        <a:t>Coping by believing in God or powers that be</a:t>
                      </a:r>
                    </a:p>
                  </a:txBody>
                  <a:tcPr marL="6161" marR="6161" marT="6161" marB="0" vert="vert270" anchor="ctr"/>
                </a:tc>
                <a:extLst>
                  <a:ext uri="{0D108BD9-81ED-4DB2-BD59-A6C34878D82A}">
                    <a16:rowId xmlns:a16="http://schemas.microsoft.com/office/drawing/2014/main" val="3839290186"/>
                  </a:ext>
                </a:extLst>
              </a:tr>
              <a:tr h="350129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Spearman-</a:t>
                      </a:r>
                      <a:r>
                        <a:rPr lang="de-DE" sz="900" u="none" strike="noStrike" dirty="0" err="1">
                          <a:effectLst/>
                        </a:rPr>
                        <a:t>Rho</a:t>
                      </a:r>
                      <a:endParaRPr lang="de-DE" sz="90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Stress </a:t>
                      </a:r>
                      <a:r>
                        <a:rPr lang="de-DE" sz="900" dirty="0" err="1"/>
                        <a:t>caused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by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unsecurity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 err="1"/>
                        <a:t>Correlation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efficient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1183572034"/>
                  </a:ext>
                </a:extLst>
              </a:tr>
              <a:tr h="178911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 </a:t>
                      </a:r>
                      <a:endParaRPr lang="de-DE" sz="90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 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p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3870534856"/>
                  </a:ext>
                </a:extLst>
              </a:tr>
              <a:tr h="521348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 </a:t>
                      </a:r>
                      <a:endParaRPr lang="de-DE" sz="90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/>
                        <a:t>Stress caused by being overwhelmed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772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dirty="0" err="1"/>
                        <a:t>Correlation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efficient</a:t>
                      </a:r>
                      <a:endParaRPr lang="de-DE" sz="900" dirty="0"/>
                    </a:p>
                    <a:p>
                      <a:pPr algn="ctr" fontAlgn="t"/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.850</a:t>
                      </a:r>
                      <a:r>
                        <a:rPr lang="de-DE" sz="900" u="none" strike="noStrike" baseline="30000" dirty="0">
                          <a:effectLst/>
                        </a:rPr>
                        <a:t>*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1698285046"/>
                  </a:ext>
                </a:extLst>
              </a:tr>
              <a:tr h="178911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/>
                        <a:t> 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p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00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3205714079"/>
                  </a:ext>
                </a:extLst>
              </a:tr>
              <a:tr h="350129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Stress </a:t>
                      </a:r>
                      <a:r>
                        <a:rPr lang="de-DE" sz="900" dirty="0" err="1"/>
                        <a:t>caused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by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loss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 err="1"/>
                        <a:t>Correlation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efficient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713</a:t>
                      </a:r>
                      <a:r>
                        <a:rPr lang="de-DE" sz="900" u="none" strike="noStrike" baseline="30000" dirty="0">
                          <a:effectLst/>
                        </a:rPr>
                        <a:t>*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714</a:t>
                      </a:r>
                      <a:r>
                        <a:rPr lang="de-DE" sz="900" u="none" strike="noStrike" baseline="30000" dirty="0">
                          <a:effectLst/>
                        </a:rPr>
                        <a:t>*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169282990"/>
                  </a:ext>
                </a:extLst>
              </a:tr>
              <a:tr h="178911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/>
                        <a:t> 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p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00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00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2307433103"/>
                  </a:ext>
                </a:extLst>
              </a:tr>
              <a:tr h="350129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Stress </a:t>
                      </a:r>
                      <a:r>
                        <a:rPr lang="de-DE" sz="900" dirty="0" err="1"/>
                        <a:t>symptoms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 err="1"/>
                        <a:t>Correlation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efficient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406</a:t>
                      </a:r>
                      <a:r>
                        <a:rPr lang="de-DE" sz="900" u="none" strike="noStrike" baseline="30000" dirty="0">
                          <a:effectLst/>
                        </a:rPr>
                        <a:t>*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513</a:t>
                      </a:r>
                      <a:r>
                        <a:rPr lang="de-DE" sz="900" u="none" strike="noStrike" baseline="30000" dirty="0">
                          <a:effectLst/>
                        </a:rPr>
                        <a:t>*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522</a:t>
                      </a:r>
                      <a:r>
                        <a:rPr lang="de-DE" sz="900" u="none" strike="noStrike" baseline="30000" dirty="0">
                          <a:effectLst/>
                        </a:rPr>
                        <a:t>*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1941475979"/>
                  </a:ext>
                </a:extLst>
              </a:tr>
              <a:tr h="178911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/>
                        <a:t> 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p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01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00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00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519571553"/>
                  </a:ext>
                </a:extLst>
              </a:tr>
              <a:tr h="350129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Positive </a:t>
                      </a:r>
                      <a:r>
                        <a:rPr lang="de-DE" sz="900" dirty="0" err="1"/>
                        <a:t>coping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 err="1"/>
                        <a:t>Correlation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efficient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103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064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239</a:t>
                      </a:r>
                      <a:r>
                        <a:rPr lang="de-DE" sz="900" u="none" strike="noStrike" baseline="30000" dirty="0">
                          <a:effectLst/>
                        </a:rPr>
                        <a:t>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260</a:t>
                      </a:r>
                      <a:r>
                        <a:rPr lang="de-DE" sz="900" u="none" strike="noStrike" baseline="30000" dirty="0">
                          <a:effectLst/>
                        </a:rPr>
                        <a:t>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641744957"/>
                  </a:ext>
                </a:extLst>
              </a:tr>
              <a:tr h="178911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/>
                        <a:t> 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p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398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619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48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36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1629418468"/>
                  </a:ext>
                </a:extLst>
              </a:tr>
              <a:tr h="350129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 err="1"/>
                        <a:t>Active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ping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 err="1"/>
                        <a:t>Correlation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efficient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053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133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122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66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275</a:t>
                      </a:r>
                      <a:r>
                        <a:rPr lang="de-DE" sz="900" u="none" strike="noStrike" baseline="30000" dirty="0">
                          <a:effectLst/>
                        </a:rPr>
                        <a:t>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3969251386"/>
                  </a:ext>
                </a:extLst>
              </a:tr>
              <a:tr h="178911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/>
                        <a:t> 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p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658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304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322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597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19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712596575"/>
                  </a:ext>
                </a:extLst>
              </a:tr>
              <a:tr h="350129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Coping </a:t>
                      </a:r>
                      <a:r>
                        <a:rPr lang="de-DE" sz="900" dirty="0" err="1"/>
                        <a:t>by</a:t>
                      </a:r>
                      <a:r>
                        <a:rPr lang="de-DE" sz="900" dirty="0"/>
                        <a:t> support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 err="1"/>
                        <a:t>Correlation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efficient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082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215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124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112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328</a:t>
                      </a:r>
                      <a:r>
                        <a:rPr lang="de-DE" sz="900" u="none" strike="noStrike" baseline="30000" dirty="0">
                          <a:effectLst/>
                        </a:rPr>
                        <a:t>*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478</a:t>
                      </a:r>
                      <a:r>
                        <a:rPr lang="de-DE" sz="900" u="none" strike="noStrike" baseline="30000" dirty="0">
                          <a:effectLst/>
                        </a:rPr>
                        <a:t>*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1569211289"/>
                  </a:ext>
                </a:extLst>
              </a:tr>
              <a:tr h="178911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/>
                        <a:t> 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p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498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94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312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372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05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00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1376628539"/>
                  </a:ext>
                </a:extLst>
              </a:tr>
              <a:tr h="350129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/>
                        <a:t>Coping by believing in God or powers that be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 err="1"/>
                        <a:t>Correlation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efficient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140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197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124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034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295</a:t>
                      </a:r>
                      <a:r>
                        <a:rPr lang="de-DE" sz="900" u="none" strike="noStrike" baseline="30000" dirty="0">
                          <a:effectLst/>
                        </a:rPr>
                        <a:t>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183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203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2503918118"/>
                  </a:ext>
                </a:extLst>
              </a:tr>
              <a:tr h="276633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/>
                        <a:t> 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/>
                        <a:t>p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239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115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305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784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11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117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82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3925219839"/>
                  </a:ext>
                </a:extLst>
              </a:tr>
              <a:tr h="509061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/>
                        <a:t>Coping by drinking alcohol and/or smoking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dirty="0" err="1"/>
                        <a:t>Correlation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coefficient</a:t>
                      </a:r>
                      <a:endParaRPr lang="de-DE" sz="900" dirty="0"/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152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79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111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183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007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368</a:t>
                      </a:r>
                      <a:r>
                        <a:rPr lang="de-DE" sz="900" u="none" strike="noStrike" baseline="30000" dirty="0">
                          <a:effectLst/>
                        </a:rPr>
                        <a:t>**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089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-0.020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1014129824"/>
                  </a:ext>
                </a:extLst>
              </a:tr>
              <a:tr h="318411"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>
                          <a:effectLst/>
                        </a:rPr>
                        <a:t> </a:t>
                      </a:r>
                      <a:endParaRPr lang="de-DE" sz="90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 </a:t>
                      </a:r>
                      <a:endParaRPr lang="de-DE" sz="90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</a:t>
                      </a: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199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533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354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133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953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001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449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u="none" strike="noStrike" dirty="0">
                          <a:effectLst/>
                        </a:rPr>
                        <a:t>0.861</a:t>
                      </a:r>
                      <a:endParaRPr lang="de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61" marR="6161" marT="6161" marB="0" anchor="ctr"/>
                </a:tc>
                <a:extLst>
                  <a:ext uri="{0D108BD9-81ED-4DB2-BD59-A6C34878D82A}">
                    <a16:rowId xmlns:a16="http://schemas.microsoft.com/office/drawing/2014/main" val="3055161872"/>
                  </a:ext>
                </a:extLst>
              </a:tr>
            </a:tbl>
          </a:graphicData>
        </a:graphic>
      </p:graphicFrame>
      <p:sp>
        <p:nvSpPr>
          <p:cNvPr id="4" name="Textfeld 1">
            <a:extLst>
              <a:ext uri="{FF2B5EF4-FFF2-40B4-BE49-F238E27FC236}">
                <a16:creationId xmlns:a16="http://schemas.microsoft.com/office/drawing/2014/main" id="{CE22DFE5-6AAE-4909-BF84-7C06FB01B077}"/>
              </a:ext>
            </a:extLst>
          </p:cNvPr>
          <p:cNvSpPr txBox="1"/>
          <p:nvPr/>
        </p:nvSpPr>
        <p:spPr>
          <a:xfrm>
            <a:off x="297316" y="400324"/>
            <a:ext cx="2682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dirty="0" err="1"/>
              <a:t>Supplemental</a:t>
            </a:r>
            <a:r>
              <a:rPr lang="de-DE" dirty="0"/>
              <a:t> </a:t>
            </a:r>
            <a:r>
              <a:rPr lang="de-DE" dirty="0"/>
              <a:t>Table </a:t>
            </a:r>
            <a:r>
              <a:rPr lang="de-DE" dirty="0"/>
              <a:t>S1</a:t>
            </a:r>
          </a:p>
        </p:txBody>
      </p:sp>
    </p:spTree>
    <p:extLst>
      <p:ext uri="{BB962C8B-B14F-4D97-AF65-F5344CB8AC3E}">
        <p14:creationId xmlns:p14="http://schemas.microsoft.com/office/powerpoint/2010/main" val="1431332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3</Words>
  <Application>Microsoft Office PowerPoint</Application>
  <PresentationFormat>A4-Papier (210 x 297 mm)</PresentationFormat>
  <Paragraphs>13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atharina Dornieden</dc:creator>
  <cp:lastModifiedBy>Bartmann, Catharina</cp:lastModifiedBy>
  <cp:revision>213</cp:revision>
  <dcterms:created xsi:type="dcterms:W3CDTF">2021-01-15T22:32:37Z</dcterms:created>
  <dcterms:modified xsi:type="dcterms:W3CDTF">2021-12-12T21:02:17Z</dcterms:modified>
</cp:coreProperties>
</file>